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55" autoAdjust="0"/>
    <p:restoredTop sz="94660"/>
  </p:normalViewPr>
  <p:slideViewPr>
    <p:cSldViewPr>
      <p:cViewPr>
        <p:scale>
          <a:sx n="100" d="100"/>
          <a:sy n="100" d="100"/>
        </p:scale>
        <p:origin x="-115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87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24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366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414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563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34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5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795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35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578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567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044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7400" y="0"/>
            <a:ext cx="18942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Table ST1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1558378"/>
              </p:ext>
            </p:extLst>
          </p:nvPr>
        </p:nvGraphicFramePr>
        <p:xfrm>
          <a:off x="914400" y="609600"/>
          <a:ext cx="4641215" cy="2194560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5940675A-B579-460E-94D1-54222C63F5DA}</a:tableStyleId>
              </a:tblPr>
              <a:tblGrid>
                <a:gridCol w="754380"/>
                <a:gridCol w="1257300"/>
                <a:gridCol w="800100"/>
                <a:gridCol w="685800"/>
                <a:gridCol w="1143635"/>
              </a:tblGrid>
              <a:tr h="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pecific Activity*</a:t>
                      </a:r>
                    </a:p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nmol P/min/mg)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Kinase</a:t>
                      </a:r>
                    </a:p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ng/mL)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TP</a:t>
                      </a:r>
                    </a:p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</a:t>
                      </a: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  <a:sym typeface="Symbol"/>
                        </a:rPr>
                        <a:t></a:t>
                      </a: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)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cubation time</a:t>
                      </a:r>
                    </a:p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min)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LK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976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SR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70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GF1R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14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0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rkA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3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rkB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51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0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rkC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034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GFR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-10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-6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MET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88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0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0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OS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277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.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.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  <a:tr h="182880"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T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641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56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25</a:t>
                      </a:r>
                      <a:endParaRPr lang="en-US" sz="120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0</a:t>
                      </a:r>
                      <a:endParaRPr lang="en-US" sz="1200" dirty="0">
                        <a:effectLst/>
                        <a:latin typeface="Times New Roman" pitchFamily="18" charset="0"/>
                        <a:ea typeface="Batang"/>
                        <a:cs typeface="Times New Roman" pitchFamily="18" charset="0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914400" y="2895600"/>
            <a:ext cx="46482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*Specific Activity as provided by manufacturer (Invitrogen)</a:t>
            </a:r>
          </a:p>
        </p:txBody>
      </p:sp>
    </p:spTree>
    <p:extLst>
      <p:ext uri="{BB962C8B-B14F-4D97-AF65-F5344CB8AC3E}">
        <p14:creationId xmlns:p14="http://schemas.microsoft.com/office/powerpoint/2010/main" val="10208419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84</Words>
  <Application>Microsoft Office PowerPoint</Application>
  <PresentationFormat>On-screen Show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Tx,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esh Narayanan</dc:creator>
  <cp:lastModifiedBy>Ramesh Narayanan</cp:lastModifiedBy>
  <cp:revision>34</cp:revision>
  <dcterms:created xsi:type="dcterms:W3CDTF">2012-07-24T16:37:13Z</dcterms:created>
  <dcterms:modified xsi:type="dcterms:W3CDTF">2013-11-13T17:12:44Z</dcterms:modified>
</cp:coreProperties>
</file>